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2539572-57A9-4F3E-94DB-E3F1B33F51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D21BAEA-E014-4B83-8D8D-8584C7AAD0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66F721D-EFEC-4453-8EAE-0C330F4CC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C70F373-A189-496C-9430-179EC1EF8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E70AFAD-74AA-4950-85EE-C259C623B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680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CF2414-ADA7-481D-8FAF-A5F3A9090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E656AA1-2D56-4235-B73B-B99E8A3E06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6171F4-DACB-44C1-96EE-DB52F2C7C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536EC0-90AD-452F-BF4A-54FA224EB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C5ED3C6-0987-465D-AF53-7CB6DD213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704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6FBE4A4-2853-44A5-8DE3-9D2A247DC0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3D4176F-788A-4E61-8C4A-0EF508D7BD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16EDCD-56BF-4B53-A254-1DC621C29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AC73740-F67C-480D-A912-52D4EDAEC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A1F5C2-624B-4E50-BB6D-98980F69E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57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B9C5F5-9E12-4DD8-8F79-E04A74E8A7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127DFDF-F0B7-44B5-BB0B-DD00FF4853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EA268A-F40C-4AFF-AF70-D60C71DC3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4C88B5-4E07-4790-980D-F85F6D0F4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56012E3-92A0-4A9E-8A49-FBC5D7663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972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D59107-4148-497C-B893-49E1A2F03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E136250-6918-451F-B377-E6902183F6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1EAE5F-409E-44B2-87FF-6CCAA8189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A988806-5E70-4481-B6DF-548890A1F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C34C3A3-0753-4156-BF3E-DC3049D08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448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1230231-5B4C-4619-B0EF-B54A262342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BCBFCB2-F3A9-4B11-81F8-19B691B577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5644FE0-AD23-4595-BD88-58313E47ED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1C77BDF-CFFE-4BF6-8EEB-27B22B82E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82D209D-987C-41B1-9232-6A5A6E65E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EE5A8CD-4264-4B98-B630-F36DCA879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95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CB1E941-E70A-4658-989D-F5734DA97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1DCEFE5-618D-4D0A-B97E-7FE883918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6D48A5E-C850-4225-A1D0-798BE5870F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C3BF562-1352-4EC1-9323-C1AEC3D328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DD8BC8E-5559-42FD-A6F8-2A68D453F5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CCA26B0-51A8-4280-9585-03EB6AC00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626711E-1098-4451-AB27-A1F9E6AB2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7203774-E5D6-4DFB-A087-14F20966E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535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C7DEBF-8ED3-4CED-AEA9-CADE75347C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A3DF633-290C-410D-8989-16EC3BEA2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7022763-8EA9-4DDE-9509-E43806279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B6641CF-1F29-4EE8-8B13-8477073AB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582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7563A14-36E9-471F-8C74-8DAC3025F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E041355-CCFC-47B8-A50B-6E52666FF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9CC18C9-AB59-4715-AC41-F73F8C642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396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346BF5-EB81-487F-A1EA-C8F95D94D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C608E24-3DB2-47B7-A0F5-6E5AAAEAAB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15D4732-BF90-417C-AD99-B44335AB62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50B9376-3158-4D9E-ABB1-327E1A6C1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1B6C33A-194A-4830-9642-28324D6CCF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3E939EE-013D-46D9-8CE5-7AA99C658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436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3FCC65-2663-4FEF-87EC-5CA8B5CB7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54DE72B-6DB4-4DF8-BE0C-D70F5E7496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BCE16A6-261B-4700-979C-9AA3FECECD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D98AF90-042F-4A59-9F7A-999F5773F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E0462E6-FBB4-4BD8-A199-04E5FF2EE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F04319F-5CB8-41DF-B78E-B9086CD169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498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3089C21-EE2A-4033-B951-6256DF9634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A363571-14D1-4727-8467-62E1E45895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D14204-1CA2-4D68-90AB-8F57FC804C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7D888-1C65-4687-B8BD-8E5916906D8D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1069F6-B010-43E0-AF89-29FB142FFC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CC62B68-B525-499B-8E3D-F643EF38B1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5617B1-EBAD-4140-B05D-480BE4B5125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67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oleObject" Target="../embeddings/oleObject5.bin"/><Relationship Id="rId18" Type="http://schemas.openxmlformats.org/officeDocument/2006/relationships/image" Target="../media/image10.tiff"/><Relationship Id="rId3" Type="http://schemas.openxmlformats.org/officeDocument/2006/relationships/image" Target="../media/image7.pn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17" Type="http://schemas.openxmlformats.org/officeDocument/2006/relationships/image" Target="../media/image9.tif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5" Type="http://schemas.openxmlformats.org/officeDocument/2006/relationships/oleObject" Target="../embeddings/oleObject6.bin"/><Relationship Id="rId10" Type="http://schemas.openxmlformats.org/officeDocument/2006/relationships/image" Target="../media/image3.emf"/><Relationship Id="rId4" Type="http://schemas.openxmlformats.org/officeDocument/2006/relationships/image" Target="../media/image8.pn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1">
            <a:extLst>
              <a:ext uri="{FF2B5EF4-FFF2-40B4-BE49-F238E27FC236}">
                <a16:creationId xmlns:a16="http://schemas.microsoft.com/office/drawing/2014/main" id="{D8010A55-87B4-4127-8319-2E5DBFDF69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4074" y="1959179"/>
            <a:ext cx="10080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5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18">
            <a:extLst>
              <a:ext uri="{FF2B5EF4-FFF2-40B4-BE49-F238E27FC236}">
                <a16:creationId xmlns:a16="http://schemas.microsoft.com/office/drawing/2014/main" id="{0ADD1A82-68D7-4516-9168-9B7D87823C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5650" y="426385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6">
            <a:extLst>
              <a:ext uri="{FF2B5EF4-FFF2-40B4-BE49-F238E27FC236}">
                <a16:creationId xmlns:a16="http://schemas.microsoft.com/office/drawing/2014/main" id="{DAA15FBF-AF84-48EA-BF76-988D9AABCE41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1156395" y="832628"/>
            <a:ext cx="97297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ramble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AA8FAC3E-70EC-47F6-BECE-D60AF378B19C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817175" y="843174"/>
            <a:ext cx="92768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rol 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9">
            <a:extLst>
              <a:ext uri="{FF2B5EF4-FFF2-40B4-BE49-F238E27FC236}">
                <a16:creationId xmlns:a16="http://schemas.microsoft.com/office/drawing/2014/main" id="{ABDD3A2B-2F16-4ADB-9FAD-12DDBF822C2E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2373473" y="885964"/>
            <a:ext cx="74651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Y/T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35142E7C-21ED-4D57-959E-96D947275DF1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1618525" y="921169"/>
            <a:ext cx="64693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YAP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B8034B4-B670-405B-ABB0-3A007193914A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1970073" y="895017"/>
            <a:ext cx="72090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-TAZ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10">
            <a:extLst>
              <a:ext uri="{FF2B5EF4-FFF2-40B4-BE49-F238E27FC236}">
                <a16:creationId xmlns:a16="http://schemas.microsoft.com/office/drawing/2014/main" id="{D92DDC89-2C95-41C0-B07D-C3FC0FC250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4074" y="1438565"/>
            <a:ext cx="44295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8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mit Pfeil 138">
            <a:extLst>
              <a:ext uri="{FF2B5EF4-FFF2-40B4-BE49-F238E27FC236}">
                <a16:creationId xmlns:a16="http://schemas.microsoft.com/office/drawing/2014/main" id="{9885A7DB-B0D9-48E3-8487-5B55D5BB5AB2}"/>
              </a:ext>
            </a:extLst>
          </p:cNvPr>
          <p:cNvCxnSpPr/>
          <p:nvPr/>
        </p:nvCxnSpPr>
        <p:spPr>
          <a:xfrm flipV="1">
            <a:off x="732434" y="698408"/>
            <a:ext cx="2183207" cy="536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feld 10">
            <a:extLst>
              <a:ext uri="{FF2B5EF4-FFF2-40B4-BE49-F238E27FC236}">
                <a16:creationId xmlns:a16="http://schemas.microsoft.com/office/drawing/2014/main" id="{82DCDE42-58FA-46D9-BDB6-4F311FB25C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384" y="1417299"/>
            <a:ext cx="52491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AP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0">
            <a:extLst>
              <a:ext uri="{FF2B5EF4-FFF2-40B4-BE49-F238E27FC236}">
                <a16:creationId xmlns:a16="http://schemas.microsoft.com/office/drawing/2014/main" id="{4501CE78-167B-4F6F-BF8E-6D46428B4A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384" y="1974568"/>
            <a:ext cx="52491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Z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0">
            <a:extLst>
              <a:ext uri="{FF2B5EF4-FFF2-40B4-BE49-F238E27FC236}">
                <a16:creationId xmlns:a16="http://schemas.microsoft.com/office/drawing/2014/main" id="{C9699B45-1679-4E9A-B2BE-61EFDE894E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4853" y="1143483"/>
            <a:ext cx="51710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1">
            <a:extLst>
              <a:ext uri="{FF2B5EF4-FFF2-40B4-BE49-F238E27FC236}">
                <a16:creationId xmlns:a16="http://schemas.microsoft.com/office/drawing/2014/main" id="{0599395D-2F88-45EC-9EA8-3B2726AB3E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4074" y="2503704"/>
            <a:ext cx="10080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2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11">
            <a:extLst>
              <a:ext uri="{FF2B5EF4-FFF2-40B4-BE49-F238E27FC236}">
                <a16:creationId xmlns:a16="http://schemas.microsoft.com/office/drawing/2014/main" id="{5F2D134A-CD43-49AD-A989-7A1FE8E05A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168" y="134133"/>
            <a:ext cx="21985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10">
            <a:extLst>
              <a:ext uri="{FF2B5EF4-FFF2-40B4-BE49-F238E27FC236}">
                <a16:creationId xmlns:a16="http://schemas.microsoft.com/office/drawing/2014/main" id="{C5E2CE9A-140E-48E4-AF59-1883DE9E69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61" y="2508460"/>
            <a:ext cx="6962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l-GR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kumimoji="0" lang="de-DE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kumimoji="0" lang="de-DE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tin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18">
            <a:extLst>
              <a:ext uri="{FF2B5EF4-FFF2-40B4-BE49-F238E27FC236}">
                <a16:creationId xmlns:a16="http://schemas.microsoft.com/office/drawing/2014/main" id="{D432C7F4-6540-44BD-993E-014AC2FD88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6968" y="3814971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Grafik 5">
            <a:extLst>
              <a:ext uri="{FF2B5EF4-FFF2-40B4-BE49-F238E27FC236}">
                <a16:creationId xmlns:a16="http://schemas.microsoft.com/office/drawing/2014/main" id="{F71D9957-A386-447E-904D-6F48F17CDD9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04" t="51097" r="57014" b="25898"/>
          <a:stretch/>
        </p:blipFill>
        <p:spPr bwMode="auto">
          <a:xfrm>
            <a:off x="733752" y="4717028"/>
            <a:ext cx="2153481" cy="963801"/>
          </a:xfrm>
          <a:prstGeom prst="rect">
            <a:avLst/>
          </a:prstGeom>
          <a:noFill/>
          <a:ln w="635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feld 10">
            <a:extLst>
              <a:ext uri="{FF2B5EF4-FFF2-40B4-BE49-F238E27FC236}">
                <a16:creationId xmlns:a16="http://schemas.microsoft.com/office/drawing/2014/main" id="{F4C7535D-4EEF-4E46-92C4-E3715EAB31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5392" y="4827150"/>
            <a:ext cx="44295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78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mit Pfeil 138">
            <a:extLst>
              <a:ext uri="{FF2B5EF4-FFF2-40B4-BE49-F238E27FC236}">
                <a16:creationId xmlns:a16="http://schemas.microsoft.com/office/drawing/2014/main" id="{E1AEB969-E85D-456A-B385-90D2D19D368D}"/>
              </a:ext>
            </a:extLst>
          </p:cNvPr>
          <p:cNvCxnSpPr/>
          <p:nvPr/>
        </p:nvCxnSpPr>
        <p:spPr>
          <a:xfrm flipV="1">
            <a:off x="733752" y="4086994"/>
            <a:ext cx="2183207" cy="536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10">
            <a:extLst>
              <a:ext uri="{FF2B5EF4-FFF2-40B4-BE49-F238E27FC236}">
                <a16:creationId xmlns:a16="http://schemas.microsoft.com/office/drawing/2014/main" id="{0754A829-FF57-4FFB-8227-3EE2262F12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702" y="4827150"/>
            <a:ext cx="52491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AP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10">
            <a:extLst>
              <a:ext uri="{FF2B5EF4-FFF2-40B4-BE49-F238E27FC236}">
                <a16:creationId xmlns:a16="http://schemas.microsoft.com/office/drawing/2014/main" id="{753DE58B-69E0-464E-9C3C-7D8EB06A97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7702" y="5322304"/>
            <a:ext cx="52491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Z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10">
            <a:extLst>
              <a:ext uri="{FF2B5EF4-FFF2-40B4-BE49-F238E27FC236}">
                <a16:creationId xmlns:a16="http://schemas.microsoft.com/office/drawing/2014/main" id="{10EE1EE3-E4AF-40AB-8549-7FF4A85BF5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34272" y="4532068"/>
            <a:ext cx="51710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Da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11">
            <a:extLst>
              <a:ext uri="{FF2B5EF4-FFF2-40B4-BE49-F238E27FC236}">
                <a16:creationId xmlns:a16="http://schemas.microsoft.com/office/drawing/2014/main" id="{8C84D367-56AD-4C28-BB36-790A966D57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486" y="3508224"/>
            <a:ext cx="21985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11">
            <a:extLst>
              <a:ext uri="{FF2B5EF4-FFF2-40B4-BE49-F238E27FC236}">
                <a16:creationId xmlns:a16="http://schemas.microsoft.com/office/drawing/2014/main" id="{6F17FA49-8858-4024-826D-43AF628297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5392" y="5306915"/>
            <a:ext cx="10080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5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11">
            <a:extLst>
              <a:ext uri="{FF2B5EF4-FFF2-40B4-BE49-F238E27FC236}">
                <a16:creationId xmlns:a16="http://schemas.microsoft.com/office/drawing/2014/main" id="{B8CF3666-383E-4293-A0AD-F142FE4DF4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5392" y="5814133"/>
            <a:ext cx="10080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2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Grafik 4">
            <a:extLst>
              <a:ext uri="{FF2B5EF4-FFF2-40B4-BE49-F238E27FC236}">
                <a16:creationId xmlns:a16="http://schemas.microsoft.com/office/drawing/2014/main" id="{B58B3E4A-CF47-4C21-B07B-588A53FFE6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078" t="38633" r="36286" b="33421"/>
          <a:stretch/>
        </p:blipFill>
        <p:spPr>
          <a:xfrm>
            <a:off x="732434" y="1328443"/>
            <a:ext cx="2152800" cy="98095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9" name="Rectangle 47">
            <a:extLst>
              <a:ext uri="{FF2B5EF4-FFF2-40B4-BE49-F238E27FC236}">
                <a16:creationId xmlns:a16="http://schemas.microsoft.com/office/drawing/2014/main" id="{A8FDE1C3-3B21-4523-9427-0AD601EBB1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4564" y="92647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3" name="Textfeld 6">
            <a:extLst>
              <a:ext uri="{FF2B5EF4-FFF2-40B4-BE49-F238E27FC236}">
                <a16:creationId xmlns:a16="http://schemas.microsoft.com/office/drawing/2014/main" id="{EE7E9E85-01F6-4339-8CB8-AF61AB80B769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1159937" y="4196078"/>
            <a:ext cx="97297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ramble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5">
            <a:extLst>
              <a:ext uri="{FF2B5EF4-FFF2-40B4-BE49-F238E27FC236}">
                <a16:creationId xmlns:a16="http://schemas.microsoft.com/office/drawing/2014/main" id="{8EDF3A39-1E9B-475D-8BD8-071E6C30916E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848127" y="4272796"/>
            <a:ext cx="74052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rol 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9">
            <a:extLst>
              <a:ext uri="{FF2B5EF4-FFF2-40B4-BE49-F238E27FC236}">
                <a16:creationId xmlns:a16="http://schemas.microsoft.com/office/drawing/2014/main" id="{82446719-C0F4-423A-AC25-F123D3D38D70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2407495" y="4249414"/>
            <a:ext cx="74651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Y/T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7">
            <a:extLst>
              <a:ext uri="{FF2B5EF4-FFF2-40B4-BE49-F238E27FC236}">
                <a16:creationId xmlns:a16="http://schemas.microsoft.com/office/drawing/2014/main" id="{A2CADFB8-AC63-408A-88A8-A3321265A419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1622067" y="4284619"/>
            <a:ext cx="64693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YAP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8">
            <a:extLst>
              <a:ext uri="{FF2B5EF4-FFF2-40B4-BE49-F238E27FC236}">
                <a16:creationId xmlns:a16="http://schemas.microsoft.com/office/drawing/2014/main" id="{B90F84AD-1E74-4263-87B4-4EB34E13DCBD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1973615" y="4258467"/>
            <a:ext cx="72090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-TAZ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8" name="Oggetto 67">
            <a:extLst>
              <a:ext uri="{FF2B5EF4-FFF2-40B4-BE49-F238E27FC236}">
                <a16:creationId xmlns:a16="http://schemas.microsoft.com/office/drawing/2014/main" id="{5CF076FD-381A-47B7-9BAA-84A604647E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2919391"/>
              </p:ext>
            </p:extLst>
          </p:nvPr>
        </p:nvGraphicFramePr>
        <p:xfrm>
          <a:off x="3467757" y="500244"/>
          <a:ext cx="2791595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" name="Prism 9" r:id="rId5" imgW="2680130" imgH="3146092" progId="Prism9.Document">
                  <p:embed/>
                </p:oleObj>
              </mc:Choice>
              <mc:Fallback>
                <p:oleObj name="Prism 9" r:id="rId5" imgW="2680130" imgH="3146092" progId="Prism9.Document">
                  <p:embed/>
                  <p:pic>
                    <p:nvPicPr>
                      <p:cNvPr id="68" name="Oggetto 67">
                        <a:extLst>
                          <a:ext uri="{FF2B5EF4-FFF2-40B4-BE49-F238E27FC236}">
                            <a16:creationId xmlns:a16="http://schemas.microsoft.com/office/drawing/2014/main" id="{5CF076FD-381A-47B7-9BAA-84A604647E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67757" y="500244"/>
                        <a:ext cx="2791595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Textfeld 18">
            <a:extLst>
              <a:ext uri="{FF2B5EF4-FFF2-40B4-BE49-F238E27FC236}">
                <a16:creationId xmlns:a16="http://schemas.microsoft.com/office/drawing/2014/main" id="{38624037-7868-4E2D-8F9C-A176E2E25C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0081" y="635490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11">
            <a:extLst>
              <a:ext uri="{FF2B5EF4-FFF2-40B4-BE49-F238E27FC236}">
                <a16:creationId xmlns:a16="http://schemas.microsoft.com/office/drawing/2014/main" id="{92400106-41CC-435A-899B-CD20E1129B17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119954" y="134133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18">
            <a:extLst>
              <a:ext uri="{FF2B5EF4-FFF2-40B4-BE49-F238E27FC236}">
                <a16:creationId xmlns:a16="http://schemas.microsoft.com/office/drawing/2014/main" id="{C0B2B7CB-7F6C-4E4F-A165-11C08363CD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91891" y="635490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11">
            <a:extLst>
              <a:ext uri="{FF2B5EF4-FFF2-40B4-BE49-F238E27FC236}">
                <a16:creationId xmlns:a16="http://schemas.microsoft.com/office/drawing/2014/main" id="{07088DA0-79D7-498E-96F5-659868EC06D1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012234" y="134133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4" name="Oggetto 73">
            <a:extLst>
              <a:ext uri="{FF2B5EF4-FFF2-40B4-BE49-F238E27FC236}">
                <a16:creationId xmlns:a16="http://schemas.microsoft.com/office/drawing/2014/main" id="{33A91ED8-13B7-4279-A448-7A1BA2D591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2513813"/>
              </p:ext>
            </p:extLst>
          </p:nvPr>
        </p:nvGraphicFramePr>
        <p:xfrm>
          <a:off x="6386349" y="514350"/>
          <a:ext cx="2789238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7" name="Prism 9" r:id="rId7" imgW="2677249" imgH="3146092" progId="Prism9.Document">
                  <p:embed/>
                </p:oleObj>
              </mc:Choice>
              <mc:Fallback>
                <p:oleObj name="Prism 9" r:id="rId7" imgW="2677249" imgH="3146092" progId="Prism9.Document">
                  <p:embed/>
                  <p:pic>
                    <p:nvPicPr>
                      <p:cNvPr id="74" name="Oggetto 73">
                        <a:extLst>
                          <a:ext uri="{FF2B5EF4-FFF2-40B4-BE49-F238E27FC236}">
                            <a16:creationId xmlns:a16="http://schemas.microsoft.com/office/drawing/2014/main" id="{33A91ED8-13B7-4279-A448-7A1BA2D591D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86349" y="514350"/>
                        <a:ext cx="2789238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Oggetto 74">
            <a:extLst>
              <a:ext uri="{FF2B5EF4-FFF2-40B4-BE49-F238E27FC236}">
                <a16:creationId xmlns:a16="http://schemas.microsoft.com/office/drawing/2014/main" id="{D2F6AA30-B7E7-4715-B427-42DC5211A7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5331002"/>
              </p:ext>
            </p:extLst>
          </p:nvPr>
        </p:nvGraphicFramePr>
        <p:xfrm>
          <a:off x="9242820" y="496888"/>
          <a:ext cx="2787650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8" name="Prism 9" r:id="rId9" imgW="2675808" imgH="3146092" progId="Prism9.Document">
                  <p:embed/>
                </p:oleObj>
              </mc:Choice>
              <mc:Fallback>
                <p:oleObj name="Prism 9" r:id="rId9" imgW="2675808" imgH="3146092" progId="Prism9.Document">
                  <p:embed/>
                  <p:pic>
                    <p:nvPicPr>
                      <p:cNvPr id="75" name="Oggetto 74">
                        <a:extLst>
                          <a:ext uri="{FF2B5EF4-FFF2-40B4-BE49-F238E27FC236}">
                            <a16:creationId xmlns:a16="http://schemas.microsoft.com/office/drawing/2014/main" id="{D2F6AA30-B7E7-4715-B427-42DC5211A7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242820" y="496888"/>
                        <a:ext cx="2787650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6" name="Textfeld 11">
            <a:extLst>
              <a:ext uri="{FF2B5EF4-FFF2-40B4-BE49-F238E27FC236}">
                <a16:creationId xmlns:a16="http://schemas.microsoft.com/office/drawing/2014/main" id="{94DB988F-624D-449F-91F4-07CA7CC1FB6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8792736" y="134133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7" name="Oggetto 76">
            <a:extLst>
              <a:ext uri="{FF2B5EF4-FFF2-40B4-BE49-F238E27FC236}">
                <a16:creationId xmlns:a16="http://schemas.microsoft.com/office/drawing/2014/main" id="{26259CE1-2D9F-4C4B-878E-D5FC941772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1945707"/>
              </p:ext>
            </p:extLst>
          </p:nvPr>
        </p:nvGraphicFramePr>
        <p:xfrm>
          <a:off x="3325495" y="3715510"/>
          <a:ext cx="2878138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Prism 9" r:id="rId11" imgW="2764042" imgH="3146092" progId="Prism9.Document">
                  <p:embed/>
                </p:oleObj>
              </mc:Choice>
              <mc:Fallback>
                <p:oleObj name="Prism 9" r:id="rId11" imgW="2764042" imgH="3146092" progId="Prism9.Document">
                  <p:embed/>
                  <p:pic>
                    <p:nvPicPr>
                      <p:cNvPr id="77" name="Oggetto 76">
                        <a:extLst>
                          <a:ext uri="{FF2B5EF4-FFF2-40B4-BE49-F238E27FC236}">
                            <a16:creationId xmlns:a16="http://schemas.microsoft.com/office/drawing/2014/main" id="{26259CE1-2D9F-4C4B-878E-D5FC941772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25495" y="3715510"/>
                        <a:ext cx="2878138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8" name="Textfeld 18">
            <a:extLst>
              <a:ext uri="{FF2B5EF4-FFF2-40B4-BE49-F238E27FC236}">
                <a16:creationId xmlns:a16="http://schemas.microsoft.com/office/drawing/2014/main" id="{C4181766-656F-4ECD-BDC2-259E082576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3246" y="3849983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11">
            <a:extLst>
              <a:ext uri="{FF2B5EF4-FFF2-40B4-BE49-F238E27FC236}">
                <a16:creationId xmlns:a16="http://schemas.microsoft.com/office/drawing/2014/main" id="{75EF8AC6-463C-429B-95AE-073D191EF2DE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3119954" y="3508224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18">
            <a:extLst>
              <a:ext uri="{FF2B5EF4-FFF2-40B4-BE49-F238E27FC236}">
                <a16:creationId xmlns:a16="http://schemas.microsoft.com/office/drawing/2014/main" id="{C19E0D45-EA97-458F-AC08-AB64558D59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98202" y="3849983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</a:p>
        </p:txBody>
      </p:sp>
      <p:sp>
        <p:nvSpPr>
          <p:cNvPr id="81" name="Textfeld 11">
            <a:extLst>
              <a:ext uri="{FF2B5EF4-FFF2-40B4-BE49-F238E27FC236}">
                <a16:creationId xmlns:a16="http://schemas.microsoft.com/office/drawing/2014/main" id="{BB59678C-D42D-4DE4-AD52-7844C3C52816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6015772" y="3508224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2" name="Oggetto 81">
            <a:extLst>
              <a:ext uri="{FF2B5EF4-FFF2-40B4-BE49-F238E27FC236}">
                <a16:creationId xmlns:a16="http://schemas.microsoft.com/office/drawing/2014/main" id="{F7099D32-2D8C-4660-BCFC-CD3E9A1F21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0096128"/>
              </p:ext>
            </p:extLst>
          </p:nvPr>
        </p:nvGraphicFramePr>
        <p:xfrm>
          <a:off x="6286183" y="3749675"/>
          <a:ext cx="2789237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0" name="Prism 9" r:id="rId13" imgW="2677249" imgH="3146092" progId="Prism9.Document">
                  <p:embed/>
                </p:oleObj>
              </mc:Choice>
              <mc:Fallback>
                <p:oleObj name="Prism 9" r:id="rId13" imgW="2677249" imgH="3146092" progId="Prism9.Document">
                  <p:embed/>
                  <p:pic>
                    <p:nvPicPr>
                      <p:cNvPr id="82" name="Oggetto 81">
                        <a:extLst>
                          <a:ext uri="{FF2B5EF4-FFF2-40B4-BE49-F238E27FC236}">
                            <a16:creationId xmlns:a16="http://schemas.microsoft.com/office/drawing/2014/main" id="{F7099D32-2D8C-4660-BCFC-CD3E9A1F21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286183" y="3749675"/>
                        <a:ext cx="2789237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3" name="Oggetto 82">
            <a:extLst>
              <a:ext uri="{FF2B5EF4-FFF2-40B4-BE49-F238E27FC236}">
                <a16:creationId xmlns:a16="http://schemas.microsoft.com/office/drawing/2014/main" id="{A83B8440-6C3C-4BFD-A2A3-AF56B232BA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4192006"/>
              </p:ext>
            </p:extLst>
          </p:nvPr>
        </p:nvGraphicFramePr>
        <p:xfrm>
          <a:off x="9194800" y="3732213"/>
          <a:ext cx="2787650" cy="3336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1" name="Prism 9" r:id="rId15" imgW="2675808" imgH="3146092" progId="Prism9.Document">
                  <p:embed/>
                </p:oleObj>
              </mc:Choice>
              <mc:Fallback>
                <p:oleObj name="Prism 9" r:id="rId15" imgW="2675808" imgH="3146092" progId="Prism9.Document">
                  <p:embed/>
                  <p:pic>
                    <p:nvPicPr>
                      <p:cNvPr id="83" name="Oggetto 82">
                        <a:extLst>
                          <a:ext uri="{FF2B5EF4-FFF2-40B4-BE49-F238E27FC236}">
                            <a16:creationId xmlns:a16="http://schemas.microsoft.com/office/drawing/2014/main" id="{A83B8440-6C3C-4BFD-A2A3-AF56B232BA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194800" y="3732213"/>
                        <a:ext cx="2787650" cy="3336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extfeld 11">
            <a:extLst>
              <a:ext uri="{FF2B5EF4-FFF2-40B4-BE49-F238E27FC236}">
                <a16:creationId xmlns:a16="http://schemas.microsoft.com/office/drawing/2014/main" id="{A5D081E0-3C45-4106-BB80-5D2E9AEB8824}"/>
              </a:ext>
            </a:extLst>
          </p:cNvPr>
          <p:cNvSpPr txBox="1">
            <a:spLocks noChangeArrowheads="1"/>
          </p:cNvSpPr>
          <p:nvPr/>
        </p:nvSpPr>
        <p:spPr bwMode="auto">
          <a:xfrm flipH="1">
            <a:off x="8744762" y="3508224"/>
            <a:ext cx="66166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</a:t>
            </a:r>
            <a:endParaRPr kumimoji="0" lang="en-US" altLang="en-US" sz="2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18">
            <a:extLst>
              <a:ext uri="{FF2B5EF4-FFF2-40B4-BE49-F238E27FC236}">
                <a16:creationId xmlns:a16="http://schemas.microsoft.com/office/drawing/2014/main" id="{4FEC3F6D-30E3-4E97-9EA3-DD0D983B59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32794" y="635490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KUM-213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18">
            <a:extLst>
              <a:ext uri="{FF2B5EF4-FFF2-40B4-BE49-F238E27FC236}">
                <a16:creationId xmlns:a16="http://schemas.microsoft.com/office/drawing/2014/main" id="{8CA28878-7E27-40CF-85A2-DE26C88366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32794" y="3849983"/>
            <a:ext cx="122704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BE</a:t>
            </a:r>
          </a:p>
        </p:txBody>
      </p:sp>
      <p:sp>
        <p:nvSpPr>
          <p:cNvPr id="87" name="Textfeld 18">
            <a:extLst>
              <a:ext uri="{FF2B5EF4-FFF2-40B4-BE49-F238E27FC236}">
                <a16:creationId xmlns:a16="http://schemas.microsoft.com/office/drawing/2014/main" id="{8B841808-FB7C-4440-8634-54BC546535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1182" y="2395611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18">
            <a:extLst>
              <a:ext uri="{FF2B5EF4-FFF2-40B4-BE49-F238E27FC236}">
                <a16:creationId xmlns:a16="http://schemas.microsoft.com/office/drawing/2014/main" id="{107F7277-BA6A-4E84-B2FE-5E3EB281341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5619" y="1008985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18">
            <a:extLst>
              <a:ext uri="{FF2B5EF4-FFF2-40B4-BE49-F238E27FC236}">
                <a16:creationId xmlns:a16="http://schemas.microsoft.com/office/drawing/2014/main" id="{252F7A11-F661-4996-B13F-1B25700C79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7233" y="2344640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18">
            <a:extLst>
              <a:ext uri="{FF2B5EF4-FFF2-40B4-BE49-F238E27FC236}">
                <a16:creationId xmlns:a16="http://schemas.microsoft.com/office/drawing/2014/main" id="{320E0306-CECA-4AAD-849A-08C678B950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56528" y="5587415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18">
            <a:extLst>
              <a:ext uri="{FF2B5EF4-FFF2-40B4-BE49-F238E27FC236}">
                <a16:creationId xmlns:a16="http://schemas.microsoft.com/office/drawing/2014/main" id="{2FFCE23B-6957-4C11-B4D5-6EEE1B3747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7390" y="4301715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18">
            <a:extLst>
              <a:ext uri="{FF2B5EF4-FFF2-40B4-BE49-F238E27FC236}">
                <a16:creationId xmlns:a16="http://schemas.microsoft.com/office/drawing/2014/main" id="{6105BE3B-8C6D-4D7A-AC9D-5CA8A09DBC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3897" y="5630965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18">
            <a:extLst>
              <a:ext uri="{FF2B5EF4-FFF2-40B4-BE49-F238E27FC236}">
                <a16:creationId xmlns:a16="http://schemas.microsoft.com/office/drawing/2014/main" id="{A48D7AD1-B87E-45A7-9F4D-16C9D337C1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8247" y="4095458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18">
            <a:extLst>
              <a:ext uri="{FF2B5EF4-FFF2-40B4-BE49-F238E27FC236}">
                <a16:creationId xmlns:a16="http://schemas.microsoft.com/office/drawing/2014/main" id="{F568757B-C248-493C-BE4D-DD164CC23E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63033" y="5420004"/>
            <a:ext cx="5897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18">
            <a:extLst>
              <a:ext uri="{FF2B5EF4-FFF2-40B4-BE49-F238E27FC236}">
                <a16:creationId xmlns:a16="http://schemas.microsoft.com/office/drawing/2014/main" id="{86BEDB55-5D54-46F0-A750-B9A9343422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96646" y="5352624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18">
            <a:extLst>
              <a:ext uri="{FF2B5EF4-FFF2-40B4-BE49-F238E27FC236}">
                <a16:creationId xmlns:a16="http://schemas.microsoft.com/office/drawing/2014/main" id="{126F87C4-1DED-4032-846F-2B00B058E7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08439" y="1200105"/>
            <a:ext cx="41262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18">
            <a:extLst>
              <a:ext uri="{FF2B5EF4-FFF2-40B4-BE49-F238E27FC236}">
                <a16:creationId xmlns:a16="http://schemas.microsoft.com/office/drawing/2014/main" id="{94F3F296-8E25-4206-A9D1-EB7F4C9A50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0673" y="2248185"/>
            <a:ext cx="5293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18">
            <a:extLst>
              <a:ext uri="{FF2B5EF4-FFF2-40B4-BE49-F238E27FC236}">
                <a16:creationId xmlns:a16="http://schemas.microsoft.com/office/drawing/2014/main" id="{BEFD9C45-5823-4CAE-AAFA-65B8EBC9F1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44701" y="2269842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feld 18">
            <a:extLst>
              <a:ext uri="{FF2B5EF4-FFF2-40B4-BE49-F238E27FC236}">
                <a16:creationId xmlns:a16="http://schemas.microsoft.com/office/drawing/2014/main" id="{7BA5D913-A5D2-4A99-B034-EAFC20AE98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93878" y="1423176"/>
            <a:ext cx="5293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8">
            <a:extLst>
              <a:ext uri="{FF2B5EF4-FFF2-40B4-BE49-F238E27FC236}">
                <a16:creationId xmlns:a16="http://schemas.microsoft.com/office/drawing/2014/main" id="{C5C67D65-B9E7-43E3-9B3B-A7F4E12C68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89153" y="1438565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8">
            <a:extLst>
              <a:ext uri="{FF2B5EF4-FFF2-40B4-BE49-F238E27FC236}">
                <a16:creationId xmlns:a16="http://schemas.microsoft.com/office/drawing/2014/main" id="{1971E855-DC4D-46DC-BD60-C6C67FB868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21229" y="2058916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8">
            <a:extLst>
              <a:ext uri="{FF2B5EF4-FFF2-40B4-BE49-F238E27FC236}">
                <a16:creationId xmlns:a16="http://schemas.microsoft.com/office/drawing/2014/main" id="{27565FA3-F2F9-4617-A33C-B01E5C4AD3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77196" y="5031259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8">
            <a:extLst>
              <a:ext uri="{FF2B5EF4-FFF2-40B4-BE49-F238E27FC236}">
                <a16:creationId xmlns:a16="http://schemas.microsoft.com/office/drawing/2014/main" id="{BBDC7109-F52B-4D30-904D-364EE12AC8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87324" y="4389554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8">
            <a:extLst>
              <a:ext uri="{FF2B5EF4-FFF2-40B4-BE49-F238E27FC236}">
                <a16:creationId xmlns:a16="http://schemas.microsoft.com/office/drawing/2014/main" id="{3B726830-38ED-435F-8942-D80CD875D9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54374" y="4602415"/>
            <a:ext cx="67973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1200" i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kumimoji="0" lang="en-US" altLang="en-US" sz="1200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Grafik 98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25" t="46136" r="44301" b="41340"/>
          <a:stretch/>
        </p:blipFill>
        <p:spPr>
          <a:xfrm>
            <a:off x="727936" y="2380664"/>
            <a:ext cx="2152800" cy="479274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06" name="Textfeld 10">
            <a:extLst>
              <a:ext uri="{FF2B5EF4-FFF2-40B4-BE49-F238E27FC236}">
                <a16:creationId xmlns:a16="http://schemas.microsoft.com/office/drawing/2014/main" id="{C5E2CE9A-140E-48E4-AF59-1883DE9E69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79" y="5829522"/>
            <a:ext cx="69623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l-GR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kumimoji="0" lang="de-DE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kumimoji="0" lang="de-DE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tin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7" name="Grafik 88">
            <a:extLst>
              <a:ext uri="{FF2B5EF4-FFF2-40B4-BE49-F238E27FC236}">
                <a16:creationId xmlns:a16="http://schemas.microsoft.com/office/drawing/2014/main" id="{28120798-FE45-479B-AB97-95657A9DA91E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47" t="42065" r="45655" b="44987"/>
          <a:stretch/>
        </p:blipFill>
        <p:spPr>
          <a:xfrm>
            <a:off x="733752" y="5764009"/>
            <a:ext cx="2152800" cy="46429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39553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F6B2CF5-B8B4-4B99-BA59-0673E1597C57}"/>
              </a:ext>
            </a:extLst>
          </p:cNvPr>
          <p:cNvSpPr txBox="1"/>
          <p:nvPr/>
        </p:nvSpPr>
        <p:spPr>
          <a:xfrm>
            <a:off x="661707" y="573363"/>
            <a:ext cx="10811435" cy="52230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15. Simultaneous silencing of TAZ and YAP impairs the </a:t>
            </a:r>
            <a:r>
              <a:rPr lang="en-US" sz="1400" b="1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 vitro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growth of human intrahepatic cholangiocarcinoma cell lines. (A) 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stern blot analysis of the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knockdown in the human KKUM-213 human intrahepatic cholangiocarcinoma cell line on TAZ and YAP protein levels. GAPDH was used as loading control. Effect of silencing at 48 hours is shown. 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B, C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uantitative real-time RT-PCR analysis 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 the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knockdown in the human KKUM-213 human intrahepatic cholangiocarcinoma cell line on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gene levels. 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knockdown on  the proliferation of the human KKUM-213 human intrahepatic cholangiocarcinoma cell line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s determined by the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roliferation assay at 48 hours. Double knockdown shows a stronger anti-proliferative effect. 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E) 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Western blot analysis of the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knockdown in the human RBE human intrahepatic cholangiocarcinoma cell line on </a:t>
            </a:r>
            <a:r>
              <a:rPr lang="en-US" sz="1400" b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YAP protein levels. GAPDH was used as loading control. Effect of silencing at 48 hours is shown. 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F, G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uantitative real-time RT-PCR analysis 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 the effects of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/or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 knockdown in the human RBE human intrahepatic cholangiocarcinoma cell line on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gene levels. </a:t>
            </a:r>
            <a:r>
              <a:rPr lang="en-US" sz="1400" b="1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ffects of TAZ and/or YAP knockdown on the proliferation of human RBE human intrahepatic cholangiocarcinoma cells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s determined by the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proliferation assay at 48 hours. Double knockdown shows a more pronounced anti-proliferative effect. Experiments were repeated at least three times in triplicate. Data are expressed as means ± SD. At least p &lt; 0.01; a, vs. control (untreated cells); b, vs. scrambled siRNA; c, vs.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ilencing; d, vs. </a:t>
            </a:r>
            <a:r>
              <a:rPr lang="en-US" sz="14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ilencing (Tukey Kramer test). Abbreviations: scramble, scrambled siRNA;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YAP, small interfering RNA against YAP;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TAZ, small interfering RNA against TAZ; </a:t>
            </a:r>
            <a:r>
              <a:rPr lang="en-US" sz="14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sz="14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Y/T, combined small interfering RNAs against YAP and TAZ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8474445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5</Words>
  <Application>Microsoft Office PowerPoint</Application>
  <PresentationFormat>Widescreen</PresentationFormat>
  <Paragraphs>59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ism 9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iego Calvisi</dc:creator>
  <cp:lastModifiedBy>Diego Calvisi</cp:lastModifiedBy>
  <cp:revision>17</cp:revision>
  <dcterms:created xsi:type="dcterms:W3CDTF">2022-02-13T11:04:23Z</dcterms:created>
  <dcterms:modified xsi:type="dcterms:W3CDTF">2022-05-06T13:35:27Z</dcterms:modified>
</cp:coreProperties>
</file>